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wmf" ContentType="image/x-wmf"/>
  <Override PartName="/ppt/embeddings/oleObject1.bin" ContentType="application/vnd.openxmlformats-officedocument.oleObject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380F0A-A099-497D-8B04-E34E735645E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311FAD-50CC-4105-BDDC-6DCFB310906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8FF83D-FFFE-4933-8424-A19AF5729A9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B4B9A3-DE35-42D3-A74F-7B654384B88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B716D2-6FA3-40FC-9C28-80E2E83E7EF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5610B6-794D-4C9A-857C-55D76CECF50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5F8C35-B863-48B4-9EE3-6698B2687E2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3B2E62-2FAE-48DB-A89E-FEEE3CFB13A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489CAC-84F8-4222-90AA-80A25B96EB1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8779A2-ECD2-4266-AC9C-1F42BE6FCA7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F664A2-8FA5-4E99-B245-620C3BA7D47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1E3F4C-ABB5-4888-8CC2-2CC423B7028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52FF8CD-2BD2-475F-8408-5EF677813AF3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4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e 1"/>
          <p:cNvGrpSpPr/>
          <p:nvPr/>
        </p:nvGrpSpPr>
        <p:grpSpPr>
          <a:xfrm>
            <a:off x="1201680" y="1913400"/>
            <a:ext cx="4587840" cy="3333600"/>
            <a:chOff x="1201680" y="1913400"/>
            <a:chExt cx="4587840" cy="3333600"/>
          </a:xfrm>
        </p:grpSpPr>
        <p:pic>
          <p:nvPicPr>
            <p:cNvPr id="42" name="Picture 3" descr="R:\Pharmacogenomique\Auteurs\François\articles\WWOX-MERIT40\BABAM1\résultats\wwox-babam1 endo (28.11.19)\merit40102.tif"/>
            <p:cNvPicPr/>
            <p:nvPr/>
          </p:nvPicPr>
          <p:blipFill>
            <a:blip r:embed="rId1"/>
            <a:srcRect l="4131" t="17935" r="4051" b="13564"/>
            <a:stretch/>
          </p:blipFill>
          <p:spPr>
            <a:xfrm>
              <a:off x="2071440" y="2959200"/>
              <a:ext cx="3315600" cy="44532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43" name="Picture 5" descr="R:\Pharmacogenomique\Auteurs\François\articles\WWOX-MERIT40\BABAM1\résultats\wwox-babam1 endo (28.11.19)\WWOX101.tif"/>
            <p:cNvPicPr/>
            <p:nvPr/>
          </p:nvPicPr>
          <p:blipFill>
            <a:blip r:embed="rId2"/>
            <a:srcRect l="9015" t="0" r="6496" b="16850"/>
            <a:stretch/>
          </p:blipFill>
          <p:spPr>
            <a:xfrm>
              <a:off x="2071440" y="3679560"/>
              <a:ext cx="3315600" cy="59472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44" name="ZoneTexte 1"/>
            <p:cNvSpPr/>
            <p:nvPr/>
          </p:nvSpPr>
          <p:spPr>
            <a:xfrm rot="17752800">
              <a:off x="2017080" y="2596680"/>
              <a:ext cx="5695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CF7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ZoneTexte 2"/>
            <p:cNvSpPr/>
            <p:nvPr/>
          </p:nvSpPr>
          <p:spPr>
            <a:xfrm rot="17752800">
              <a:off x="2324520" y="2641320"/>
              <a:ext cx="5144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T47D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ZoneTexte 3"/>
            <p:cNvSpPr/>
            <p:nvPr/>
          </p:nvSpPr>
          <p:spPr>
            <a:xfrm rot="17752800">
              <a:off x="2473200" y="2385000"/>
              <a:ext cx="10447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DA-MB-361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ZoneTexte 4"/>
            <p:cNvSpPr/>
            <p:nvPr/>
          </p:nvSpPr>
          <p:spPr>
            <a:xfrm rot="17752800">
              <a:off x="2772360" y="2344320"/>
              <a:ext cx="1122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DA-MB-435S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ZoneTexte 5"/>
            <p:cNvSpPr/>
            <p:nvPr/>
          </p:nvSpPr>
          <p:spPr>
            <a:xfrm rot="17752800">
              <a:off x="3159360" y="2379600"/>
              <a:ext cx="10447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DA-MB-231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ZoneTexte 6"/>
            <p:cNvSpPr/>
            <p:nvPr/>
          </p:nvSpPr>
          <p:spPr>
            <a:xfrm rot="17752800">
              <a:off x="3530520" y="2385000"/>
              <a:ext cx="10447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DA-MB-157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ZoneTexte 7"/>
            <p:cNvSpPr/>
            <p:nvPr/>
          </p:nvSpPr>
          <p:spPr>
            <a:xfrm rot="17752800">
              <a:off x="3970440" y="2624760"/>
              <a:ext cx="5068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T2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ZoneTexte 8"/>
            <p:cNvSpPr/>
            <p:nvPr/>
          </p:nvSpPr>
          <p:spPr>
            <a:xfrm rot="17752800">
              <a:off x="4144680" y="2379600"/>
              <a:ext cx="10447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DA-MB-468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ZoneTexte 9"/>
            <p:cNvSpPr/>
            <p:nvPr/>
          </p:nvSpPr>
          <p:spPr>
            <a:xfrm rot="17752800">
              <a:off x="4561920" y="2517840"/>
              <a:ext cx="726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K-BR-3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ZoneTexte 10"/>
            <p:cNvSpPr/>
            <p:nvPr/>
          </p:nvSpPr>
          <p:spPr>
            <a:xfrm rot="17752800">
              <a:off x="4898520" y="2518200"/>
              <a:ext cx="7340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BL-10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54" name="Picture 2" descr="R:\Pharmacogenomique\Auteurs\François\articles\WWOX-MERIT40\BABAM1\résultats\wwox-babam1 endo (28.11.19)\gapdh103.tif"/>
            <p:cNvPicPr/>
            <p:nvPr/>
          </p:nvPicPr>
          <p:blipFill>
            <a:blip r:embed="rId3"/>
            <a:srcRect l="2384" t="23020" r="4542" b="15718"/>
            <a:stretch/>
          </p:blipFill>
          <p:spPr>
            <a:xfrm>
              <a:off x="2128320" y="4543920"/>
              <a:ext cx="3315600" cy="48636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55" name="ZoneTexte 13"/>
            <p:cNvSpPr/>
            <p:nvPr/>
          </p:nvSpPr>
          <p:spPr>
            <a:xfrm>
              <a:off x="1201680" y="3029040"/>
              <a:ext cx="7948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ERIT4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ZoneTexte 20"/>
            <p:cNvSpPr/>
            <p:nvPr/>
          </p:nvSpPr>
          <p:spPr>
            <a:xfrm>
              <a:off x="1339560" y="3864240"/>
              <a:ext cx="6714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WWOX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ZoneTexte 21"/>
            <p:cNvSpPr/>
            <p:nvPr/>
          </p:nvSpPr>
          <p:spPr>
            <a:xfrm>
              <a:off x="1364400" y="4707000"/>
              <a:ext cx="6865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GAPDH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Triangle isocèle 20"/>
            <p:cNvSpPr/>
            <p:nvPr/>
          </p:nvSpPr>
          <p:spPr>
            <a:xfrm flipH="1" rot="5400000">
              <a:off x="1934280" y="3138120"/>
              <a:ext cx="90360" cy="6156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Triangle isocèle 21"/>
            <p:cNvSpPr/>
            <p:nvPr/>
          </p:nvSpPr>
          <p:spPr>
            <a:xfrm flipH="1" rot="5400000">
              <a:off x="1938960" y="3962160"/>
              <a:ext cx="90360" cy="6156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Triangle isocèle 22"/>
            <p:cNvSpPr/>
            <p:nvPr/>
          </p:nvSpPr>
          <p:spPr>
            <a:xfrm flipH="1" rot="5400000">
              <a:off x="1991520" y="4800240"/>
              <a:ext cx="90360" cy="6156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ZoneTexte 1"/>
            <p:cNvSpPr/>
            <p:nvPr/>
          </p:nvSpPr>
          <p:spPr>
            <a:xfrm>
              <a:off x="2075400" y="5015880"/>
              <a:ext cx="34556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0226   6821  11203/10939  10897   6298   7479   7974  14560  17509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ZoneTexte 23"/>
            <p:cNvSpPr/>
            <p:nvPr/>
          </p:nvSpPr>
          <p:spPr>
            <a:xfrm>
              <a:off x="2044800" y="3391560"/>
              <a:ext cx="34556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2852 13913 12662/21579  13006   11838 11685 15173 15624  2033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ZoneTexte 24"/>
            <p:cNvSpPr/>
            <p:nvPr/>
          </p:nvSpPr>
          <p:spPr>
            <a:xfrm>
              <a:off x="2048760" y="4255920"/>
              <a:ext cx="3426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2851 19113  23074  4143   2572    1674   7959  22776/24208  11775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ZoneTexte 194"/>
            <p:cNvSpPr/>
            <p:nvPr/>
          </p:nvSpPr>
          <p:spPr>
            <a:xfrm>
              <a:off x="5361120" y="3913200"/>
              <a:ext cx="3600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50  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Connecteur droit 26"/>
            <p:cNvSpPr/>
            <p:nvPr/>
          </p:nvSpPr>
          <p:spPr>
            <a:xfrm>
              <a:off x="5391360" y="4032360"/>
              <a:ext cx="42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ZoneTexte 209"/>
            <p:cNvSpPr/>
            <p:nvPr/>
          </p:nvSpPr>
          <p:spPr>
            <a:xfrm>
              <a:off x="5360760" y="3060720"/>
              <a:ext cx="3618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50  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Connecteur droit 28"/>
            <p:cNvSpPr/>
            <p:nvPr/>
          </p:nvSpPr>
          <p:spPr>
            <a:xfrm>
              <a:off x="5391360" y="3181320"/>
              <a:ext cx="42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ZoneTexte 209"/>
            <p:cNvSpPr/>
            <p:nvPr/>
          </p:nvSpPr>
          <p:spPr>
            <a:xfrm>
              <a:off x="5427720" y="4673880"/>
              <a:ext cx="3618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6  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Connecteur droit 30"/>
            <p:cNvSpPr/>
            <p:nvPr/>
          </p:nvSpPr>
          <p:spPr>
            <a:xfrm>
              <a:off x="5457960" y="4794480"/>
              <a:ext cx="42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70" name="Rectangle 1"/>
          <p:cNvSpPr/>
          <p:nvPr/>
        </p:nvSpPr>
        <p:spPr>
          <a:xfrm>
            <a:off x="692280" y="5246640"/>
            <a:ext cx="5761080" cy="153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200000"/>
              </a:lnSpc>
              <a:spcAft>
                <a:spcPts val="799"/>
              </a:spcAft>
              <a:tabLst>
                <a:tab algn="l" pos="0"/>
                <a:tab algn="l" pos="449280"/>
                <a:tab algn="l" pos="99072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 u="sng">
                <a:solidFill>
                  <a:srgbClr val="000000"/>
                </a:solidFill>
                <a:uFillTx/>
                <a:latin typeface="Times New Roman"/>
                <a:ea typeface="Calibri"/>
              </a:rPr>
              <a:t>Figure S1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Calibri"/>
              </a:rPr>
              <a:t>: </a:t>
            </a:r>
            <a:r>
              <a:rPr b="1" lang="en-GB" sz="1100" spc="-1" strike="noStrike">
                <a:solidFill>
                  <a:srgbClr val="000000"/>
                </a:solidFill>
                <a:latin typeface="Times New Roman"/>
                <a:ea typeface="Calibri"/>
              </a:rPr>
              <a:t>MERIT40 and WWOX expressions in different breast cell lines.</a:t>
            </a:r>
            <a:r>
              <a:rPr b="0" lang="en-GB" sz="1100" spc="-1" strike="noStrike">
                <a:solidFill>
                  <a:srgbClr val="000000"/>
                </a:solidFill>
                <a:latin typeface="Times New Roman"/>
                <a:ea typeface="Calibri"/>
              </a:rPr>
              <a:t> Cell lysates of various breast cell lines were examined by immunoblotting with anti-MERIT40, anti-WWOX, and anti-GAPDH antibodies as indicated.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200000"/>
              </a:lnSpc>
              <a:spcAft>
                <a:spcPts val="799"/>
              </a:spcAft>
              <a:tabLst>
                <a:tab algn="l" pos="0"/>
                <a:tab algn="l" pos="449280"/>
                <a:tab algn="l" pos="99072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Times New Roman"/>
                <a:ea typeface="Calibri"/>
              </a:rPr>
              <a:t> 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1" name="Objet 1"/>
          <p:cNvGraphicFramePr/>
          <p:nvPr/>
        </p:nvGraphicFramePr>
        <p:xfrm>
          <a:off x="2060640" y="2476440"/>
          <a:ext cx="2825640" cy="33894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72" name="Objet 1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060640" y="2476440"/>
                    <a:ext cx="2825640" cy="3389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73" name="ZoneTexte 4"/>
          <p:cNvSpPr/>
          <p:nvPr/>
        </p:nvSpPr>
        <p:spPr>
          <a:xfrm>
            <a:off x="3259440" y="2548080"/>
            <a:ext cx="653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=0,00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74" name="Groupe 23"/>
          <p:cNvGrpSpPr/>
          <p:nvPr/>
        </p:nvGrpSpPr>
        <p:grpSpPr>
          <a:xfrm>
            <a:off x="2903400" y="2835360"/>
            <a:ext cx="1279800" cy="114120"/>
            <a:chOff x="2903400" y="2835360"/>
            <a:chExt cx="1279800" cy="114120"/>
          </a:xfrm>
        </p:grpSpPr>
        <p:sp>
          <p:nvSpPr>
            <p:cNvPr id="75" name="Connecteur droit 4"/>
            <p:cNvSpPr/>
            <p:nvPr/>
          </p:nvSpPr>
          <p:spPr>
            <a:xfrm flipV="1">
              <a:off x="2903400" y="2835360"/>
              <a:ext cx="1279800" cy="10800"/>
            </a:xfrm>
            <a:prstGeom prst="line">
              <a:avLst/>
            </a:prstGeom>
            <a:ln w="936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Connecteur droit 5"/>
            <p:cNvSpPr/>
            <p:nvPr/>
          </p:nvSpPr>
          <p:spPr>
            <a:xfrm>
              <a:off x="4178520" y="2835360"/>
              <a:ext cx="0" cy="103320"/>
            </a:xfrm>
            <a:prstGeom prst="line">
              <a:avLst/>
            </a:prstGeom>
            <a:ln w="936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Connecteur droit 6"/>
            <p:cNvSpPr/>
            <p:nvPr/>
          </p:nvSpPr>
          <p:spPr>
            <a:xfrm>
              <a:off x="2909520" y="2846160"/>
              <a:ext cx="0" cy="103320"/>
            </a:xfrm>
            <a:prstGeom prst="line">
              <a:avLst/>
            </a:prstGeom>
            <a:ln w="936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78" name="ZoneTexte 4"/>
          <p:cNvSpPr/>
          <p:nvPr/>
        </p:nvSpPr>
        <p:spPr>
          <a:xfrm rot="16200000">
            <a:off x="999360" y="3870000"/>
            <a:ext cx="18752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lative</a:t>
            </a:r>
            <a:r>
              <a:rPr b="0" i="1" lang="fr-FR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MERIT40 </a:t>
            </a:r>
            <a:r>
              <a:rPr b="0" lang="fr-FR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xpression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Rectangle 1"/>
          <p:cNvSpPr/>
          <p:nvPr/>
        </p:nvSpPr>
        <p:spPr>
          <a:xfrm>
            <a:off x="620640" y="6033960"/>
            <a:ext cx="5616720" cy="76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200000"/>
              </a:lnSpc>
              <a:spcAft>
                <a:spcPts val="799"/>
              </a:spcAft>
              <a:tabLst>
                <a:tab algn="l" pos="0"/>
                <a:tab algn="l" pos="449280"/>
                <a:tab algn="l" pos="99072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 u="sng">
                <a:solidFill>
                  <a:srgbClr val="000000"/>
                </a:solidFill>
                <a:uFillTx/>
                <a:latin typeface="Times New Roman"/>
                <a:ea typeface="Calibri"/>
              </a:rPr>
              <a:t>Figure S2</a:t>
            </a:r>
            <a:r>
              <a:rPr b="1" lang="en-GB" sz="1100" spc="-1" strike="noStrike">
                <a:solidFill>
                  <a:srgbClr val="000000"/>
                </a:solidFill>
                <a:latin typeface="Times New Roman"/>
                <a:ea typeface="Calibri"/>
              </a:rPr>
              <a:t>: </a:t>
            </a:r>
            <a:r>
              <a:rPr b="1" i="1" lang="en-US" sz="1100" spc="-1" strike="noStrike">
                <a:solidFill>
                  <a:srgbClr val="000000"/>
                </a:solidFill>
                <a:latin typeface="Times New Roman"/>
                <a:ea typeface="Calibri"/>
              </a:rPr>
              <a:t>MERIT40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Calibri"/>
              </a:rPr>
              <a:t> expression in</a:t>
            </a:r>
            <a:r>
              <a:rPr b="1" lang="fr-FR" sz="1100" spc="-1" strike="noStrike">
                <a:solidFill>
                  <a:srgbClr val="131413"/>
                </a:solidFill>
                <a:latin typeface="Times New Roman"/>
                <a:ea typeface="Calibri"/>
              </a:rPr>
              <a:t> human breast tumors.</a:t>
            </a:r>
            <a:r>
              <a:rPr b="0" lang="fr-FR" sz="1100" spc="-1" strike="noStrike">
                <a:solidFill>
                  <a:srgbClr val="131413"/>
                </a:solidFill>
                <a:latin typeface="Times New Roman"/>
                <a:ea typeface="Calibri"/>
              </a:rPr>
              <a:t> </a:t>
            </a:r>
            <a:r>
              <a:rPr b="0" i="1" lang="en-US" sz="1100" spc="-1" strike="noStrike">
                <a:solidFill>
                  <a:srgbClr val="000000"/>
                </a:solidFill>
                <a:latin typeface="Times New Roman"/>
                <a:ea typeface="Calibri"/>
              </a:rPr>
              <a:t>MERIT40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Calibri"/>
              </a:rPr>
              <a:t> transcripts levels in</a:t>
            </a:r>
            <a:r>
              <a:rPr b="0" lang="fr-FR" sz="1100" spc="-1" strike="noStrike">
                <a:solidFill>
                  <a:srgbClr val="131413"/>
                </a:solidFill>
                <a:latin typeface="Times New Roman"/>
                <a:ea typeface="Calibri"/>
              </a:rPr>
              <a:t> human breast tumors of Curie cohort (n=499)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Calibri"/>
              </a:rPr>
              <a:t> as compared to normal breast tissue (n=14).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05-18T14:35:52Z</dcterms:created>
  <dc:creator>Admin Christian Normand</dc:creator>
  <dc:description/>
  <dc:language>en-US</dc:language>
  <cp:lastModifiedBy>Lallemand Francois</cp:lastModifiedBy>
  <dcterms:modified xsi:type="dcterms:W3CDTF">2023-05-05T12:44:46Z</dcterms:modified>
  <cp:revision>26</cp:revision>
  <dc:subject/>
  <dc:title>Présentation PowerPoint</dc:title>
</cp:coreProperties>
</file>